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07" r:id="rId2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7"/>
    <a:srgbClr val="99FFCC"/>
    <a:srgbClr val="FFFF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3" autoAdjust="0"/>
    <p:restoredTop sz="95139" autoAdjust="0"/>
  </p:normalViewPr>
  <p:slideViewPr>
    <p:cSldViewPr>
      <p:cViewPr varScale="1">
        <p:scale>
          <a:sx n="116" d="100"/>
          <a:sy n="116" d="100"/>
        </p:scale>
        <p:origin x="828" y="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25" d="100"/>
        <a:sy n="125" d="100"/>
      </p:scale>
      <p:origin x="0" y="2333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0338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6421AE8-B305-4190-935A-A6C830857FE3}" type="datetimeFigureOut">
              <a:rPr lang="en-US" smtClean="0"/>
              <a:t>9/1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0338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C5630FF-F02B-4626-82E1-C46299F894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756051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ADDAC483-7313-4644-970F-0EDFC3A106FE}" type="datetimeFigureOut">
              <a:rPr lang="en-US" smtClean="0"/>
              <a:t>9/10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811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CEC04829-1CB9-4F51-8A07-D65AE5A986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64797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9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7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5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9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1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3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9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4702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9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77475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42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42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9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39907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9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64663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4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89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37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13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9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07045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4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4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9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56935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7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7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9/1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62671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9/1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30036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9/1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27933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2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4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2" y="1435103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7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1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9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56801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7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1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7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1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9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54627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4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4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FCCB72-9C25-4AD7-B59B-5176EE691596}" type="datetimeFigureOut">
              <a:rPr lang="en-US" smtClean="0"/>
              <a:t>9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4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4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41129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377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91" indent="-342891" algn="l" defTabSz="914377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32" indent="-285744" algn="l" defTabSz="914377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1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914377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9" indent="-228594" algn="l" defTabSz="914377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4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7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1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B421D97E-5A8A-4FD0-B67B-976FCCCF12D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3855" b="3024"/>
          <a:stretch/>
        </p:blipFill>
        <p:spPr>
          <a:xfrm>
            <a:off x="659698" y="914401"/>
            <a:ext cx="7824603" cy="3657600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28661109-D6A6-4B1D-B050-3A989BA63181}"/>
              </a:ext>
            </a:extLst>
          </p:cNvPr>
          <p:cNvSpPr/>
          <p:nvPr/>
        </p:nvSpPr>
        <p:spPr>
          <a:xfrm>
            <a:off x="762000" y="5029200"/>
            <a:ext cx="7824603" cy="132343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ea typeface="Times New Roman" panose="02020603050405020304" pitchFamily="18" charset="0"/>
              </a:rPr>
              <a:t>Additional file 2</a:t>
            </a:r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. QTL analysis results of D2.HD-F</a:t>
            </a:r>
            <a:r>
              <a:rPr lang="en-US" sz="1600" b="1" baseline="-250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2</a:t>
            </a:r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 and the combined D2.HD-N</a:t>
            </a:r>
            <a:r>
              <a:rPr lang="en-US" sz="1600" b="1" baseline="-250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2</a:t>
            </a:r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 and D2.HD-F</a:t>
            </a:r>
            <a:r>
              <a:rPr lang="en-US" sz="1600" b="1" baseline="-250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2</a:t>
            </a:r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 cohorts.</a:t>
            </a:r>
            <a:r>
              <a:rPr lang="en-US" sz="16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 D2.HD-F</a:t>
            </a:r>
            <a:r>
              <a:rPr lang="en-US" sz="1600" baseline="-250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2</a:t>
            </a:r>
            <a:r>
              <a:rPr lang="en-US" sz="16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 (16 affected, 16 unaffected) and D2.HD-N</a:t>
            </a:r>
            <a:r>
              <a:rPr lang="en-US" sz="1600" baseline="-250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2</a:t>
            </a:r>
            <a:r>
              <a:rPr lang="en-US" sz="16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 (19 affected, 6 unaffected) were combined and run as a single population (n=57) using an F</a:t>
            </a:r>
            <a:r>
              <a:rPr lang="en-US" sz="1600" baseline="-250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2 </a:t>
            </a:r>
            <a:r>
              <a:rPr lang="en-US" sz="16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scenario in R/</a:t>
            </a:r>
            <a:r>
              <a:rPr lang="en-US" sz="1600" dirty="0" err="1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qtl</a:t>
            </a:r>
            <a:r>
              <a:rPr lang="en-US" sz="16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. </a:t>
            </a:r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A.</a:t>
            </a:r>
            <a:r>
              <a:rPr lang="en-US" sz="16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 D2.HD-F</a:t>
            </a:r>
            <a:r>
              <a:rPr lang="en-US" sz="1600" baseline="-250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2</a:t>
            </a:r>
            <a:r>
              <a:rPr lang="en-US" sz="16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 plot </a:t>
            </a:r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B.</a:t>
            </a:r>
            <a:r>
              <a:rPr lang="en-US" sz="16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 Combined plot. No significance was identified for F</a:t>
            </a:r>
            <a:r>
              <a:rPr lang="en-US" sz="1600" baseline="-250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2</a:t>
            </a:r>
            <a:r>
              <a:rPr lang="en-US" sz="16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 or the combined populations.</a:t>
            </a:r>
            <a:endParaRPr lang="en-US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59079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>
        <a:solidFill>
          <a:schemeClr val="bg1"/>
        </a:solidFill>
      </a:spPr>
      <a:bodyPr wrap="square" lIns="0" tIns="0" rIns="0" bIns="0" rtlCol="0">
        <a:spAutoFit/>
      </a:bodyPr>
      <a:lstStyle>
        <a:defPPr algn="r">
          <a:lnSpc>
            <a:spcPts val="5700"/>
          </a:lnSpc>
          <a:defRPr sz="1400" b="1" dirty="0" smtClean="0"/>
        </a:defPPr>
      </a:lstStyle>
    </a:tx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3852</TotalTime>
  <Words>88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MS Mincho</vt:lpstr>
      <vt:lpstr>Arial</vt:lpstr>
      <vt:lpstr>Calibri</vt:lpstr>
      <vt:lpstr>Times New Roman</vt:lpstr>
      <vt:lpstr>Office Theme</vt:lpstr>
      <vt:lpstr>PowerPoint Presentation</vt:lpstr>
    </vt:vector>
  </TitlesOfParts>
  <Company>CCH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CHMC</dc:creator>
  <cp:lastModifiedBy>prop73</cp:lastModifiedBy>
  <cp:revision>331</cp:revision>
  <cp:lastPrinted>2019-04-17T14:37:59Z</cp:lastPrinted>
  <dcterms:created xsi:type="dcterms:W3CDTF">2012-04-10T18:38:20Z</dcterms:created>
  <dcterms:modified xsi:type="dcterms:W3CDTF">2019-09-10T10:32:22Z</dcterms:modified>
</cp:coreProperties>
</file>